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85" autoAdjust="0"/>
    <p:restoredTop sz="96247" autoAdjust="0"/>
  </p:normalViewPr>
  <p:slideViewPr>
    <p:cSldViewPr snapToGrid="0">
      <p:cViewPr>
        <p:scale>
          <a:sx n="150" d="100"/>
          <a:sy n="150" d="100"/>
        </p:scale>
        <p:origin x="762" y="-28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205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57E124-7984-47DF-9DB3-96261744DEEC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1D031-33C9-4BD1-86F3-2A3FA351121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4920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A1D031-33C9-4BD1-86F3-2A3FA351121D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335670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9409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0580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3730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84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483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2628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72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301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1004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0430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6953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023C0-FC84-4236-83BA-364191644CDB}" type="datetimeFigureOut">
              <a:rPr lang="en-IN" smtClean="0"/>
              <a:t>30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1368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FAE48232-0832-B37F-703B-469D5B48C9FC}"/>
              </a:ext>
            </a:extLst>
          </p:cNvPr>
          <p:cNvGrpSpPr/>
          <p:nvPr/>
        </p:nvGrpSpPr>
        <p:grpSpPr>
          <a:xfrm>
            <a:off x="309844" y="611925"/>
            <a:ext cx="6238312" cy="3708345"/>
            <a:chOff x="309844" y="611925"/>
            <a:chExt cx="6238312" cy="3708345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F749A42-E1E0-F3E0-A995-178A37C224D2}"/>
                </a:ext>
              </a:extLst>
            </p:cNvPr>
            <p:cNvGrpSpPr/>
            <p:nvPr/>
          </p:nvGrpSpPr>
          <p:grpSpPr>
            <a:xfrm>
              <a:off x="309844" y="611925"/>
              <a:ext cx="6238312" cy="3690372"/>
              <a:chOff x="629385" y="591453"/>
              <a:chExt cx="6238312" cy="3690372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E5456D70-1D70-C0D0-10BC-643C52814A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800" t="22484" r="25791" b="23044"/>
              <a:stretch>
                <a:fillRect/>
              </a:stretch>
            </p:blipFill>
            <p:spPr>
              <a:xfrm>
                <a:off x="1170850" y="930811"/>
                <a:ext cx="2268564" cy="1618021"/>
              </a:xfrm>
              <a:prstGeom prst="rect">
                <a:avLst/>
              </a:prstGeom>
            </p:spPr>
          </p:pic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40DBAE45-4016-8A7D-702D-5AEE3D81A88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549863" y="849362"/>
                <a:ext cx="2273300" cy="1780918"/>
                <a:chOff x="3340100" y="3889612"/>
                <a:chExt cx="2273300" cy="1780918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C3C624F9-AD4D-7F62-0E1D-164DAC34DD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907" t="23002" r="26945" b="22525"/>
                <a:stretch>
                  <a:fillRect/>
                </a:stretch>
              </p:blipFill>
              <p:spPr>
                <a:xfrm>
                  <a:off x="3340100" y="3889612"/>
                  <a:ext cx="2273300" cy="1780918"/>
                </a:xfrm>
                <a:prstGeom prst="rect">
                  <a:avLst/>
                </a:prstGeom>
              </p:spPr>
            </p:pic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5E711C8C-D89B-2DA0-5AAE-AC408FA691DA}"/>
                    </a:ext>
                  </a:extLst>
                </p:cNvPr>
                <p:cNvSpPr/>
                <p:nvPr/>
              </p:nvSpPr>
              <p:spPr>
                <a:xfrm>
                  <a:off x="3509920" y="3889612"/>
                  <a:ext cx="400508" cy="171293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sz="1400"/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E3080FAB-ACC3-10C7-5526-3DEE94F7D8F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170850" y="2756187"/>
                <a:ext cx="2265771" cy="1525638"/>
                <a:chOff x="338156" y="2871793"/>
                <a:chExt cx="3029045" cy="2039588"/>
              </a:xfrm>
            </p:grpSpPr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79544F55-A66A-B756-A3DF-226D8D6D65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8156" y="2871793"/>
                  <a:ext cx="3029045" cy="2039588"/>
                </a:xfrm>
                <a:prstGeom prst="rect">
                  <a:avLst/>
                </a:prstGeom>
              </p:spPr>
            </p:pic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37D2923B-C86D-2F51-7C12-E9D44EFCC9DE}"/>
                    </a:ext>
                  </a:extLst>
                </p:cNvPr>
                <p:cNvSpPr/>
                <p:nvPr/>
              </p:nvSpPr>
              <p:spPr>
                <a:xfrm>
                  <a:off x="2435225" y="2968625"/>
                  <a:ext cx="504825" cy="39052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sz="1400"/>
                </a:p>
              </p:txBody>
            </p: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3B156150-F76A-BCFF-C881-8517A407D4E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558594" y="2765010"/>
                <a:ext cx="2492576" cy="1507991"/>
                <a:chOff x="328344" y="4994620"/>
                <a:chExt cx="3048667" cy="1844421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554BEB2D-57F2-257F-E0FF-E611EDADA7E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8344" y="4994620"/>
                  <a:ext cx="3048667" cy="1844421"/>
                </a:xfrm>
                <a:prstGeom prst="rect">
                  <a:avLst/>
                </a:prstGeom>
              </p:spPr>
            </p:pic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FC3C370F-6BB6-1CBD-8CC1-79AD8C537019}"/>
                    </a:ext>
                  </a:extLst>
                </p:cNvPr>
                <p:cNvSpPr/>
                <p:nvPr/>
              </p:nvSpPr>
              <p:spPr>
                <a:xfrm>
                  <a:off x="1152525" y="4994620"/>
                  <a:ext cx="504825" cy="39052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sz="1400"/>
                </a:p>
              </p:txBody>
            </p:sp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A47B3756-A997-2F42-E26A-0A509556F63E}"/>
                  </a:ext>
                </a:extLst>
              </p:cNvPr>
              <p:cNvSpPr txBox="1"/>
              <p:nvPr/>
            </p:nvSpPr>
            <p:spPr>
              <a:xfrm>
                <a:off x="666254" y="1565900"/>
                <a:ext cx="58381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rk</a:t>
                </a:r>
                <a:endParaRPr lang="en-IN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0CA8F55-4B45-7CA5-BD3A-48F690D97BD1}"/>
                  </a:ext>
                </a:extLst>
              </p:cNvPr>
              <p:cNvSpPr txBox="1"/>
              <p:nvPr/>
            </p:nvSpPr>
            <p:spPr>
              <a:xfrm>
                <a:off x="629385" y="3365118"/>
                <a:ext cx="6206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ight</a:t>
                </a:r>
                <a:endParaRPr lang="en-IN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F856561-E743-1471-6B33-A41D2A5AC232}"/>
                  </a:ext>
                </a:extLst>
              </p:cNvPr>
              <p:cNvSpPr txBox="1"/>
              <p:nvPr/>
            </p:nvSpPr>
            <p:spPr>
              <a:xfrm>
                <a:off x="1894603" y="591453"/>
                <a:ext cx="82105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IN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E93616A-7F64-1510-9323-3877CBFB42F8}"/>
                  </a:ext>
                </a:extLst>
              </p:cNvPr>
              <p:cNvSpPr txBox="1"/>
              <p:nvPr/>
            </p:nvSpPr>
            <p:spPr>
              <a:xfrm>
                <a:off x="4221482" y="591453"/>
                <a:ext cx="9300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ysteine</a:t>
                </a:r>
                <a:endParaRPr lang="en-IN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89A575E-6E7E-D734-CBCF-6CC10972DB26}"/>
                  </a:ext>
                </a:extLst>
              </p:cNvPr>
              <p:cNvSpPr txBox="1"/>
              <p:nvPr/>
            </p:nvSpPr>
            <p:spPr>
              <a:xfrm>
                <a:off x="5976106" y="3365118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0 mM</a:t>
                </a:r>
                <a:endParaRPr lang="en-IN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BE7584C1-A27F-47BE-7B91-5E3A68746CB7}"/>
                  </a:ext>
                </a:extLst>
              </p:cNvPr>
              <p:cNvSpPr txBox="1"/>
              <p:nvPr/>
            </p:nvSpPr>
            <p:spPr>
              <a:xfrm>
                <a:off x="5928338" y="1565900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5 mM</a:t>
                </a:r>
                <a:endParaRPr lang="en-IN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DA80DE20-0C93-1BFC-D25D-589037AAC109}"/>
                </a:ext>
              </a:extLst>
            </p:cNvPr>
            <p:cNvSpPr/>
            <p:nvPr/>
          </p:nvSpPr>
          <p:spPr>
            <a:xfrm>
              <a:off x="388965" y="648270"/>
              <a:ext cx="6084000" cy="367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5926B719-BEFE-1E55-EEF6-45C49BE0FE6E}"/>
              </a:ext>
            </a:extLst>
          </p:cNvPr>
          <p:cNvSpPr txBox="1"/>
          <p:nvPr/>
        </p:nvSpPr>
        <p:spPr>
          <a:xfrm>
            <a:off x="620184" y="5184806"/>
            <a:ext cx="588020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uence of L-cysteine on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hatham root. The top panel 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hows th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ongation of  WT and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ots of Dark-grown seedlings, in the presence and absence of L-cysteine (0.05 mM). The bottom panel shows the elongation of  WT and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ots of Light-grown seedlings, in the presence and absence of L-cysteine (0.10 mM). </a:t>
            </a:r>
            <a:endParaRPr lang="en-US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4261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67</TotalTime>
  <Words>73</Words>
  <Application>Microsoft Office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18</cp:revision>
  <dcterms:created xsi:type="dcterms:W3CDTF">2025-06-16T09:20:07Z</dcterms:created>
  <dcterms:modified xsi:type="dcterms:W3CDTF">2025-06-30T10:33:32Z</dcterms:modified>
</cp:coreProperties>
</file>